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00" r:id="rId2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064" userDrawn="1">
          <p15:clr>
            <a:srgbClr val="A4A3A4"/>
          </p15:clr>
        </p15:guide>
        <p15:guide id="2" pos="42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600FF"/>
    <a:srgbClr val="A5FF6B"/>
    <a:srgbClr val="FF9231"/>
    <a:srgbClr val="EA003F"/>
    <a:srgbClr val="E13AFE"/>
    <a:srgbClr val="DB9700"/>
    <a:srgbClr val="00F2A1"/>
    <a:srgbClr val="00907C"/>
    <a:srgbClr val="4A4FC5"/>
    <a:srgbClr val="E9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395"/>
    <p:restoredTop sz="94694"/>
  </p:normalViewPr>
  <p:slideViewPr>
    <p:cSldViewPr snapToGrid="0" snapToObjects="1">
      <p:cViewPr varScale="1">
        <p:scale>
          <a:sx n="82" d="100"/>
          <a:sy n="82" d="100"/>
        </p:scale>
        <p:origin x="4080" y="192"/>
      </p:cViewPr>
      <p:guideLst>
        <p:guide orient="horz" pos="5064"/>
        <p:guide pos="4224"/>
      </p:guideLst>
    </p:cSldViewPr>
  </p:slideViewPr>
  <p:notesTextViewPr>
    <p:cViewPr>
      <p:scale>
        <a:sx n="85" d="100"/>
        <a:sy n="8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0D109F-9FEC-DA44-A69C-E029EAED4A05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1143000"/>
            <a:ext cx="2244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61CA8D-B548-7247-B2E9-BB70CA9702F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32029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61CA8D-B548-7247-B2E9-BB70CA9702F1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786704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2762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4313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7355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9613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8210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0563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0571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9294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2369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9584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1881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2347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2CC4F87-8A3A-1A4E-9878-593A04AD4F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2489900"/>
              </p:ext>
            </p:extLst>
          </p:nvPr>
        </p:nvGraphicFramePr>
        <p:xfrm>
          <a:off x="2232120" y="3341563"/>
          <a:ext cx="2949576" cy="83343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83192">
                  <a:extLst>
                    <a:ext uri="{9D8B030D-6E8A-4147-A177-3AD203B41FA5}">
                      <a16:colId xmlns:a16="http://schemas.microsoft.com/office/drawing/2014/main" val="1440789753"/>
                    </a:ext>
                  </a:extLst>
                </a:gridCol>
                <a:gridCol w="983192">
                  <a:extLst>
                    <a:ext uri="{9D8B030D-6E8A-4147-A177-3AD203B41FA5}">
                      <a16:colId xmlns:a16="http://schemas.microsoft.com/office/drawing/2014/main" val="1066095409"/>
                    </a:ext>
                  </a:extLst>
                </a:gridCol>
                <a:gridCol w="983192">
                  <a:extLst>
                    <a:ext uri="{9D8B030D-6E8A-4147-A177-3AD203B41FA5}">
                      <a16:colId xmlns:a16="http://schemas.microsoft.com/office/drawing/2014/main" val="3652813672"/>
                    </a:ext>
                  </a:extLst>
                </a:gridCol>
              </a:tblGrid>
              <a:tr h="277811">
                <a:tc>
                  <a:txBody>
                    <a:bodyPr/>
                    <a:lstStyle/>
                    <a:p>
                      <a:endParaRPr 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54</a:t>
                      </a: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G3</a:t>
                      </a: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7174323"/>
                  </a:ext>
                </a:extLst>
              </a:tr>
              <a:tr h="277811">
                <a:tc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ope</a:t>
                      </a: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54</a:t>
                      </a: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29</a:t>
                      </a: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563201"/>
                  </a:ext>
                </a:extLst>
              </a:tr>
              <a:tr h="277811">
                <a:tc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squared</a:t>
                      </a: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</a:t>
                      </a: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5872938"/>
                  </a:ext>
                </a:extLst>
              </a:tr>
            </a:tbl>
          </a:graphicData>
        </a:graphic>
      </p:graphicFrame>
      <p:grpSp>
        <p:nvGrpSpPr>
          <p:cNvPr id="5" name="Group 4">
            <a:extLst>
              <a:ext uri="{FF2B5EF4-FFF2-40B4-BE49-F238E27FC236}">
                <a16:creationId xmlns:a16="http://schemas.microsoft.com/office/drawing/2014/main" id="{A7C32806-B5E6-7641-9827-87E7B5C04422}"/>
              </a:ext>
            </a:extLst>
          </p:cNvPr>
          <p:cNvGrpSpPr/>
          <p:nvPr/>
        </p:nvGrpSpPr>
        <p:grpSpPr>
          <a:xfrm>
            <a:off x="1589345" y="4263049"/>
            <a:ext cx="4154699" cy="3539811"/>
            <a:chOff x="1589345" y="4596362"/>
            <a:chExt cx="4154699" cy="3539811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90F09FC-FC01-C44C-959D-14F83E64535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669773" y="4682288"/>
              <a:ext cx="4074271" cy="3453885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EDDBFD7-3D63-8145-ADC7-D7EB4B27212D}"/>
                </a:ext>
              </a:extLst>
            </p:cNvPr>
            <p:cNvSpPr txBox="1"/>
            <p:nvPr/>
          </p:nvSpPr>
          <p:spPr>
            <a:xfrm>
              <a:off x="1589345" y="4596362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4FD4244F-629D-6E4A-9FF9-2709F3F0B424}"/>
              </a:ext>
            </a:extLst>
          </p:cNvPr>
          <p:cNvGrpSpPr/>
          <p:nvPr/>
        </p:nvGrpSpPr>
        <p:grpSpPr>
          <a:xfrm>
            <a:off x="1594911" y="525086"/>
            <a:ext cx="3958078" cy="2787314"/>
            <a:chOff x="1594911" y="1341518"/>
            <a:chExt cx="3958078" cy="2787314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2D5C8140-1824-8649-A5E7-0BD51E83BD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481"/>
            <a:stretch/>
          </p:blipFill>
          <p:spPr>
            <a:xfrm>
              <a:off x="1934987" y="1442315"/>
              <a:ext cx="3618002" cy="2686517"/>
            </a:xfrm>
            <a:prstGeom prst="rect">
              <a:avLst/>
            </a:prstGeom>
          </p:spPr>
        </p:pic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4FE08AF3-5225-2347-A046-26570CF74460}"/>
                </a:ext>
              </a:extLst>
            </p:cNvPr>
            <p:cNvGrpSpPr/>
            <p:nvPr/>
          </p:nvGrpSpPr>
          <p:grpSpPr>
            <a:xfrm>
              <a:off x="1594911" y="1341518"/>
              <a:ext cx="3468761" cy="2220874"/>
              <a:chOff x="1594911" y="858399"/>
              <a:chExt cx="3468761" cy="2220874"/>
            </a:xfrm>
          </p:grpSpPr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93E18AEE-7999-FB44-84AB-E6D71736839B}"/>
                  </a:ext>
                </a:extLst>
              </p:cNvPr>
              <p:cNvSpPr txBox="1"/>
              <p:nvPr/>
            </p:nvSpPr>
            <p:spPr>
              <a:xfrm>
                <a:off x="1594911" y="858399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FBB4F9D1-FE9A-3541-8831-92304E1C1CE5}"/>
                  </a:ext>
                </a:extLst>
              </p:cNvPr>
              <p:cNvSpPr txBox="1"/>
              <p:nvPr/>
            </p:nvSpPr>
            <p:spPr>
              <a:xfrm rot="16200000">
                <a:off x="990366" y="2125710"/>
                <a:ext cx="1630126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∆Ct (Marker – </a:t>
                </a:r>
                <a:r>
                  <a:rPr lang="en-US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CTB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24CBE975-EA3A-E647-B8C1-93E66A2415A9}"/>
                  </a:ext>
                </a:extLst>
              </p:cNvPr>
              <p:cNvSpPr/>
              <p:nvPr/>
            </p:nvSpPr>
            <p:spPr>
              <a:xfrm>
                <a:off x="4604770" y="1598758"/>
                <a:ext cx="386861" cy="1406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39D3E3FA-38DD-AC4A-8C53-AD9218C68024}"/>
                  </a:ext>
                </a:extLst>
              </p:cNvPr>
              <p:cNvSpPr txBox="1"/>
              <p:nvPr/>
            </p:nvSpPr>
            <p:spPr>
              <a:xfrm>
                <a:off x="4497334" y="1532392"/>
                <a:ext cx="566338" cy="26161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CG3</a:t>
                </a:r>
              </a:p>
            </p:txBody>
          </p:sp>
        </p:grpSp>
      </p:grpSp>
      <p:sp>
        <p:nvSpPr>
          <p:cNvPr id="15" name="Rectangle 14">
            <a:extLst>
              <a:ext uri="{FF2B5EF4-FFF2-40B4-BE49-F238E27FC236}">
                <a16:creationId xmlns:a16="http://schemas.microsoft.com/office/drawing/2014/main" id="{25C40F59-CD89-AA44-9DE4-55792ED6F0E1}"/>
              </a:ext>
            </a:extLst>
          </p:cNvPr>
          <p:cNvSpPr/>
          <p:nvPr/>
        </p:nvSpPr>
        <p:spPr>
          <a:xfrm>
            <a:off x="1242786" y="7888786"/>
            <a:ext cx="5484586" cy="13542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. S3</a:t>
            </a:r>
            <a:r>
              <a:rPr lang="en-US" sz="11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: Performance characteristics of TAM-MSP. </a:t>
            </a:r>
            <a:endParaRPr lang="en-US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 algn="just">
              <a:spcAft>
                <a:spcPts val="600"/>
              </a:spcAft>
            </a:pPr>
            <a:r>
              <a:rPr lang="en-US" sz="11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 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 standard curve was generated by mixing fully methylated (Sss1-treated) human sperm DNA (HSD) with fully unmethylated HSD to yield dilutions of 3-100 % methylation. Each dot represents the average ∆Ct value (Ct of sample-Ct of </a:t>
            </a:r>
            <a:r>
              <a:rPr lang="en-US" sz="1100" i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CTB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) of 6 replicates. </a:t>
            </a:r>
            <a:r>
              <a:rPr lang="en-US" sz="11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b 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Inter-assay reproducibility was calculated from the ∆</a:t>
            </a:r>
            <a:r>
              <a:rPr lang="en-US" sz="11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ts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generated from the standard curve in </a:t>
            </a:r>
            <a:r>
              <a:rPr lang="en-US" sz="11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 M= methylated; N = number of replicates; CV = coefficient of variation; P =Mann-Whitney statistics. </a:t>
            </a:r>
            <a:endParaRPr lang="en-US" sz="1100" dirty="0">
              <a:effectLst/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45554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77</TotalTime>
  <Words>120</Words>
  <Application>Microsoft Macintosh PowerPoint</Application>
  <PresentationFormat>Custom</PresentationFormat>
  <Paragraphs>1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adley Downs</dc:creator>
  <cp:lastModifiedBy>Bradley Downs</cp:lastModifiedBy>
  <cp:revision>452</cp:revision>
  <cp:lastPrinted>2021-03-15T15:34:39Z</cp:lastPrinted>
  <dcterms:created xsi:type="dcterms:W3CDTF">2019-09-14T17:51:09Z</dcterms:created>
  <dcterms:modified xsi:type="dcterms:W3CDTF">2021-04-29T19:11:44Z</dcterms:modified>
</cp:coreProperties>
</file>